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96"/>
  </p:normalViewPr>
  <p:slideViewPr>
    <p:cSldViewPr snapToGrid="0">
      <p:cViewPr>
        <p:scale>
          <a:sx n="51" d="100"/>
          <a:sy n="51" d="100"/>
        </p:scale>
        <p:origin x="1176" y="1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12/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N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7612A400-ABCC-7A3D-08AC-A1509A43FF5D}"/>
              </a:ext>
            </a:extLst>
          </p:cNvPr>
          <p:cNvSpPr txBox="1"/>
          <p:nvPr/>
        </p:nvSpPr>
        <p:spPr>
          <a:xfrm>
            <a:off x="673773" y="4597135"/>
            <a:ext cx="6070251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WB Co-IP in transfected HEK 293T </a:t>
            </a:r>
          </a:p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ells transfected with plasmid expressing FANCJ-Flag WT (input sample)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ells transfected with plasmid expressing FANCJ-Flag AALA (input sample)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ells transfected with the empty vector (input sample)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o sample</a:t>
            </a:r>
          </a:p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o-IP with Flag beads /FANCJ-Flag WT 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o-IP with Flag beads / FANCJ-Flag AALA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o-IP with Flag beads/ empty vector</a:t>
            </a:r>
          </a:p>
        </p:txBody>
      </p:sp>
      <p:grpSp>
        <p:nvGrpSpPr>
          <p:cNvPr id="28" name="Gruppo 27">
            <a:extLst>
              <a:ext uri="{FF2B5EF4-FFF2-40B4-BE49-F238E27FC236}">
                <a16:creationId xmlns:a16="http://schemas.microsoft.com/office/drawing/2014/main" id="{3E6B53AE-2550-5DAB-49F6-877A62DD7789}"/>
              </a:ext>
            </a:extLst>
          </p:cNvPr>
          <p:cNvGrpSpPr/>
          <p:nvPr/>
        </p:nvGrpSpPr>
        <p:grpSpPr>
          <a:xfrm>
            <a:off x="6003095" y="611623"/>
            <a:ext cx="4464879" cy="3523811"/>
            <a:chOff x="768316" y="337930"/>
            <a:chExt cx="4464879" cy="3523811"/>
          </a:xfrm>
        </p:grpSpPr>
        <p:pic>
          <p:nvPicPr>
            <p:cNvPr id="5" name="Immagine 4" descr="Immagine che contiene testo, calligrafia, bianco e nero, lavagna&#10;&#10;Descrizione generata automaticamente">
              <a:extLst>
                <a:ext uri="{FF2B5EF4-FFF2-40B4-BE49-F238E27FC236}">
                  <a16:creationId xmlns:a16="http://schemas.microsoft.com/office/drawing/2014/main" id="{4465DB85-D52D-493A-CC71-04A98F96BA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6000" contrast="-5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68316" y="337930"/>
              <a:ext cx="4464879" cy="3091070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CAF74B13-1AF5-DEE4-7BEF-79B8011B806B}"/>
                </a:ext>
              </a:extLst>
            </p:cNvPr>
            <p:cNvSpPr txBox="1"/>
            <p:nvPr/>
          </p:nvSpPr>
          <p:spPr>
            <a:xfrm>
              <a:off x="2082748" y="3492409"/>
              <a:ext cx="16261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Long exposure</a:t>
              </a:r>
            </a:p>
          </p:txBody>
        </p:sp>
        <p:sp>
          <p:nvSpPr>
            <p:cNvPr id="13" name="Rettangolo 12">
              <a:extLst>
                <a:ext uri="{FF2B5EF4-FFF2-40B4-BE49-F238E27FC236}">
                  <a16:creationId xmlns:a16="http://schemas.microsoft.com/office/drawing/2014/main" id="{778F2A47-1427-ABC5-8A8A-4CEDB0C9AD86}"/>
                </a:ext>
              </a:extLst>
            </p:cNvPr>
            <p:cNvSpPr/>
            <p:nvPr/>
          </p:nvSpPr>
          <p:spPr>
            <a:xfrm>
              <a:off x="1671563" y="2383228"/>
              <a:ext cx="1027031" cy="24845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B342BD7A-AD88-31B7-1E81-C6109D91ACCA}"/>
                </a:ext>
              </a:extLst>
            </p:cNvPr>
            <p:cNvSpPr/>
            <p:nvPr/>
          </p:nvSpPr>
          <p:spPr>
            <a:xfrm>
              <a:off x="3045724" y="2383228"/>
              <a:ext cx="1027031" cy="24845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39B113B0-A4A0-BB86-78B2-DFC3AE2A6BB7}"/>
                </a:ext>
              </a:extLst>
            </p:cNvPr>
            <p:cNvSpPr txBox="1"/>
            <p:nvPr/>
          </p:nvSpPr>
          <p:spPr>
            <a:xfrm>
              <a:off x="1359319" y="79557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CFFD95F7-EA82-5435-E8A8-D6E7495CF0EF}"/>
                </a:ext>
              </a:extLst>
            </p:cNvPr>
            <p:cNvSpPr txBox="1"/>
            <p:nvPr/>
          </p:nvSpPr>
          <p:spPr>
            <a:xfrm>
              <a:off x="1359319" y="62536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48BEE398-6C39-4911-2318-EDD9DA035EDB}"/>
                </a:ext>
              </a:extLst>
            </p:cNvPr>
            <p:cNvSpPr txBox="1"/>
            <p:nvPr/>
          </p:nvSpPr>
          <p:spPr>
            <a:xfrm>
              <a:off x="1370732" y="1419196"/>
              <a:ext cx="4281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725B0770-E821-246C-1178-1CA028B29BAA}"/>
                </a:ext>
              </a:extLst>
            </p:cNvPr>
            <p:cNvSpPr txBox="1"/>
            <p:nvPr/>
          </p:nvSpPr>
          <p:spPr>
            <a:xfrm>
              <a:off x="1089109" y="218613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50B4805F-BFAE-BA00-6CF5-DD1D1B69B79D}"/>
                </a:ext>
              </a:extLst>
            </p:cNvPr>
            <p:cNvSpPr txBox="1"/>
            <p:nvPr/>
          </p:nvSpPr>
          <p:spPr>
            <a:xfrm>
              <a:off x="1089109" y="201593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AD01AB32-BFA2-3D59-F703-3246AB73C013}"/>
                </a:ext>
              </a:extLst>
            </p:cNvPr>
            <p:cNvSpPr txBox="1"/>
            <p:nvPr/>
          </p:nvSpPr>
          <p:spPr>
            <a:xfrm>
              <a:off x="1100522" y="2809760"/>
              <a:ext cx="4281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</p:grpSp>
      <p:grpSp>
        <p:nvGrpSpPr>
          <p:cNvPr id="27" name="Gruppo 26">
            <a:extLst>
              <a:ext uri="{FF2B5EF4-FFF2-40B4-BE49-F238E27FC236}">
                <a16:creationId xmlns:a16="http://schemas.microsoft.com/office/drawing/2014/main" id="{16C11106-2877-845C-9F4A-AD12F81EF07A}"/>
              </a:ext>
            </a:extLst>
          </p:cNvPr>
          <p:cNvGrpSpPr/>
          <p:nvPr/>
        </p:nvGrpSpPr>
        <p:grpSpPr>
          <a:xfrm>
            <a:off x="478651" y="561383"/>
            <a:ext cx="3927468" cy="3398963"/>
            <a:chOff x="6955651" y="401337"/>
            <a:chExt cx="3927468" cy="3398963"/>
          </a:xfrm>
        </p:grpSpPr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2C1E33B3-F0C1-314F-222B-6A737D5600F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17000" contrast="3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955651" y="401337"/>
              <a:ext cx="3927468" cy="2964255"/>
            </a:xfrm>
            <a:prstGeom prst="rect">
              <a:avLst/>
            </a:prstGeom>
          </p:spPr>
        </p:pic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664135EA-04FE-C330-FCC1-A6EEE94DB9CC}"/>
                </a:ext>
              </a:extLst>
            </p:cNvPr>
            <p:cNvSpPr txBox="1"/>
            <p:nvPr/>
          </p:nvSpPr>
          <p:spPr>
            <a:xfrm>
              <a:off x="8094474" y="3430968"/>
              <a:ext cx="16800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Short exposure</a:t>
              </a:r>
            </a:p>
          </p:txBody>
        </p:sp>
        <p:sp>
          <p:nvSpPr>
            <p:cNvPr id="12" name="Rettangolo 11">
              <a:extLst>
                <a:ext uri="{FF2B5EF4-FFF2-40B4-BE49-F238E27FC236}">
                  <a16:creationId xmlns:a16="http://schemas.microsoft.com/office/drawing/2014/main" id="{65A31C93-3C2A-AE39-120E-1622375E4AC9}"/>
                </a:ext>
              </a:extLst>
            </p:cNvPr>
            <p:cNvSpPr/>
            <p:nvPr/>
          </p:nvSpPr>
          <p:spPr>
            <a:xfrm>
              <a:off x="7876857" y="902368"/>
              <a:ext cx="942290" cy="23461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5BDC8477-F5C9-BF4F-CF8D-A02CAED99DF0}"/>
                </a:ext>
              </a:extLst>
            </p:cNvPr>
            <p:cNvSpPr txBox="1"/>
            <p:nvPr/>
          </p:nvSpPr>
          <p:spPr>
            <a:xfrm>
              <a:off x="7196482" y="76386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CCCE6F91-1C3E-AE4E-21E3-B4ECCAC1E7C2}"/>
                </a:ext>
              </a:extLst>
            </p:cNvPr>
            <p:cNvSpPr txBox="1"/>
            <p:nvPr/>
          </p:nvSpPr>
          <p:spPr>
            <a:xfrm>
              <a:off x="7207895" y="1347150"/>
              <a:ext cx="4281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02BBF69F-E17B-3DCA-736E-6E6E195C98C6}"/>
                </a:ext>
              </a:extLst>
            </p:cNvPr>
            <p:cNvSpPr txBox="1"/>
            <p:nvPr/>
          </p:nvSpPr>
          <p:spPr>
            <a:xfrm>
              <a:off x="6976710" y="2074984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5FE77C52-8483-3000-F8C9-C5597FFE1C86}"/>
                </a:ext>
              </a:extLst>
            </p:cNvPr>
            <p:cNvSpPr txBox="1"/>
            <p:nvPr/>
          </p:nvSpPr>
          <p:spPr>
            <a:xfrm>
              <a:off x="6988123" y="2658266"/>
              <a:ext cx="4281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390407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ma di Office</Template>
  <TotalTime>31</TotalTime>
  <Words>76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MARIA PISANI</dc:creator>
  <cp:lastModifiedBy>FRANCESCA MARIA PISANI</cp:lastModifiedBy>
  <cp:revision>2</cp:revision>
  <dcterms:created xsi:type="dcterms:W3CDTF">2023-11-30T14:07:36Z</dcterms:created>
  <dcterms:modified xsi:type="dcterms:W3CDTF">2023-12-02T15:24:40Z</dcterms:modified>
</cp:coreProperties>
</file>